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53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A9C6BA-94CF-DA28-A87A-30C67C80E2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5CA5699-8B8B-37E2-93E7-0188991D474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925BDE-A86E-A74A-DC91-45CE281E6A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E0A88-15AE-4D77-B8C5-852AD084DE71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3B9565-9F54-B886-3AA4-FAF65B2ADF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45577E-C9CA-52EB-9C82-CFA49DD8FC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CD798-015B-43E5-9700-559EFCF8F7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7501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FEB4F5-A829-CA10-72E7-E46CC67AB6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E96BD9C-2F24-D812-91DC-875227CE8D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E4E786-7E9A-8251-D348-1B4017AAE2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E0A88-15AE-4D77-B8C5-852AD084DE71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DB74C4-144C-BB11-D950-92236E02AD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0B41FC-CD64-6CBE-320C-5D51741E61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CD798-015B-43E5-9700-559EFCF8F7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23256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B3D5DAE-6DAA-0172-7CBE-D6468122D1E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AC98163-086D-5BD5-BF49-D28BE9E81B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0203BC-90E7-BF59-1FDA-C696513BBF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E0A88-15AE-4D77-B8C5-852AD084DE71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243FD2-FF99-DF4E-9714-B47B388205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4DF228-078C-FE09-21EC-B71F838D6C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CD798-015B-43E5-9700-559EFCF8F7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87290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EB26F4-D9C9-85F9-B95D-DE0351BA58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658D42-8C85-8107-D0E1-8D876043B92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AFC177-F80F-8F64-3A37-16767A9D60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E0A88-15AE-4D77-B8C5-852AD084DE71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3E184A-4BFA-B816-CB97-2A25FEE4B2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68E6FE-8C6E-8054-8AE6-EAE98B2253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CD798-015B-43E5-9700-559EFCF8F7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09276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AE41F5-0E59-98AE-3B06-6E0B589897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8331485-BE43-134E-C64B-5826989BEC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EC3D34-3347-FD32-562C-F87FEE58B4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E0A88-15AE-4D77-B8C5-852AD084DE71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CDD518-8710-D533-9FB5-31AE45425F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5632D9-B984-2BB3-B78E-D9534B8B42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CD798-015B-43E5-9700-559EFCF8F7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7075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88BF21-3458-5B93-D0F6-5399D508A1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C9F573-50F8-AB39-8ECB-91829FE0D5E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5A18258-327A-4159-398B-9E50181345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E15BEF-87FB-A1E7-42B4-BC08737447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E0A88-15AE-4D77-B8C5-852AD084DE71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D5D0297-C269-3808-4AEE-473CF347A1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38EA2AC-AD30-55A4-3926-22AC61BC37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CD798-015B-43E5-9700-559EFCF8F7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24651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9BF9A3-C86B-13F3-8238-59265D79A0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964D8E-2F27-C7E8-8C65-4101A48F57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0158EA7-1C74-41EC-23FF-C07A03D5D7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90E57D7-3D34-0856-BD3E-E4ADDE8D97B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4EA21D4-5871-1EC9-D86E-AE85A97A182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929D924-8B56-3BB5-0617-C0A0861EAB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E0A88-15AE-4D77-B8C5-852AD084DE71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935F2F6-E0CB-C35E-2DFE-D4F01B5FFB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29F0D49-6F2F-8091-694A-69F831C7FC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CD798-015B-43E5-9700-559EFCF8F7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25721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CF4E5E-FBBB-689D-ACD8-E48DB647BE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5DE3FEC-725F-976E-CF29-67D41A3A30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E0A88-15AE-4D77-B8C5-852AD084DE71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BB7947D-B7C8-6C72-21A6-009DCDEC85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2AE2066-F56C-4711-D4DA-1ADF2F939B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CD798-015B-43E5-9700-559EFCF8F7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7751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B167C5F-83EA-317F-EDEE-788DFB351E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E0A88-15AE-4D77-B8C5-852AD084DE71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32C20B7-716B-9E83-2EC2-0CD2913B19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77C2F36-ED62-3BD9-E426-69A1936EB3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CD798-015B-43E5-9700-559EFCF8F7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7427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D3FAF9-DF38-E45B-21D4-B58870F0EB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79808E-93E1-5AC5-C3E9-14B89A54757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437C2CA-117B-7D48-FEF7-919A9FB62C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0EB9E54-375D-EF82-E6B1-57BC570CFA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E0A88-15AE-4D77-B8C5-852AD084DE71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3B6194-5A28-58E0-0F92-CC6C9ADBEF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09392A-24D2-59BD-7FB9-738D4CCB65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CD798-015B-43E5-9700-559EFCF8F7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0384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EBBA85-3BB9-C9A7-B9F9-7FB706A2A4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4637047-28CD-EB2E-2E45-82291DBBC93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B352A3F-94B6-33BC-F086-83FEF6093B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8E5BD9-EFCD-01D6-7EFC-8A59553B52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E0A88-15AE-4D77-B8C5-852AD084DE71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4A5F7A-0DFA-063D-B610-49C64BFC34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37B92E-11E0-C901-58D5-1584D6FFF0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CD798-015B-43E5-9700-559EFCF8F7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6070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1ECFFA8-4F54-14C4-93B5-D11DC7BC67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A04A54-9D65-F6CC-1F27-36E1C977DE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0A1CF6-A475-A2B8-DE6C-7E929EBDCF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78E0A88-15AE-4D77-B8C5-852AD084DE71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BB2B67-7558-B5B3-DBA4-A4049B8B9F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F44BC5-BCA9-2005-9224-928622B0FAF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A9CD798-015B-43E5-9700-559EFCF8F7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0715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73E06D-1079-E017-FA88-6C3F08DD99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722077" y="154131"/>
            <a:ext cx="4600626" cy="127672"/>
          </a:xfrm>
        </p:spPr>
        <p:txBody>
          <a:bodyPr>
            <a:noAutofit/>
          </a:bodyPr>
          <a:lstStyle/>
          <a:p>
            <a:r>
              <a:rPr lang="en-US" sz="762" b="1">
                <a:latin typeface="Arial" panose="020B0604020202020204" pitchFamily="34" charset="0"/>
                <a:ea typeface="Calibri Light"/>
                <a:cs typeface="Arial" panose="020B0604020202020204" pitchFamily="34" charset="0"/>
              </a:rPr>
              <a:t>ORIEN estimated immune abundances</a:t>
            </a:r>
            <a:endParaRPr lang="en-US" sz="623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 descr="A screenshot of a graph&#10;&#10;AI-generated content may be incorrect.">
            <a:extLst>
              <a:ext uri="{FF2B5EF4-FFF2-40B4-BE49-F238E27FC236}">
                <a16:creationId xmlns:a16="http://schemas.microsoft.com/office/drawing/2014/main" id="{EF6664DC-7E43-BD3D-7A31-A79B36E136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22077" y="315912"/>
            <a:ext cx="4749700" cy="4747846"/>
          </a:xfrm>
          <a:prstGeom prst="rect">
            <a:avLst/>
          </a:prstGeom>
        </p:spPr>
      </p:pic>
      <p:sp>
        <p:nvSpPr>
          <p:cNvPr id="3" name="Title 1">
            <a:extLst>
              <a:ext uri="{FF2B5EF4-FFF2-40B4-BE49-F238E27FC236}">
                <a16:creationId xmlns:a16="http://schemas.microsoft.com/office/drawing/2014/main" id="{412577FE-3989-89B9-106A-37E5D58942A4}"/>
              </a:ext>
            </a:extLst>
          </p:cNvPr>
          <p:cNvSpPr txBox="1">
            <a:spLocks/>
          </p:cNvSpPr>
          <p:nvPr/>
        </p:nvSpPr>
        <p:spPr>
          <a:xfrm>
            <a:off x="3722077" y="5205363"/>
            <a:ext cx="4747847" cy="365125"/>
          </a:xfrm>
          <a:prstGeom prst="rect">
            <a:avLst/>
          </a:prstGeom>
        </p:spPr>
        <p:txBody>
          <a:bodyPr vert="horz" lIns="63305" tIns="31652" rIns="63305" bIns="31652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762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 Estimated immune cell composition in tumors stratified by EO vs AO CRC in the ORIEN dataset. </a:t>
            </a:r>
            <a:r>
              <a:rPr lang="en-US" sz="762" dirty="0">
                <a:latin typeface="Arial" panose="020B0604020202020204" pitchFamily="34" charset="0"/>
                <a:cs typeface="Arial" panose="020B0604020202020204" pitchFamily="34" charset="0"/>
              </a:rPr>
              <a:t>Statistically significant abundances by t-test, adjusted for multiple hypothesis testing, are shown in the plots. Those without specified p-values were greater than 0.05.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DD21624-A7D0-FF43-5E79-5FA97EEE1AA7}"/>
              </a:ext>
            </a:extLst>
          </p:cNvPr>
          <p:cNvSpPr txBox="1"/>
          <p:nvPr/>
        </p:nvSpPr>
        <p:spPr>
          <a:xfrm>
            <a:off x="96143" y="57948"/>
            <a:ext cx="288480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Aptos" panose="020B0004020202020204" pitchFamily="34" charset="0"/>
              </a:rPr>
              <a:t>Supplementary </a:t>
            </a:r>
            <a:r>
              <a:rPr lang="en-US" sz="1800" b="1">
                <a:solidFill>
                  <a:srgbClr val="000000"/>
                </a:solidFill>
                <a:effectLst/>
                <a:latin typeface="Aptos" panose="020B0004020202020204" pitchFamily="34" charset="0"/>
              </a:rPr>
              <a:t>Figure S3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40199823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8db864bc-821c-4dd3-a9c9-5002b5129ec6}" enabled="1" method="Standard" siteId="{0b95a125-791c-4f0a-9f9e-99e363117506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5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ORIEN estimated immune abundanc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in, Ning</dc:creator>
  <cp:lastModifiedBy>Dahlberg, Angela</cp:lastModifiedBy>
  <cp:revision>2</cp:revision>
  <dcterms:created xsi:type="dcterms:W3CDTF">2025-09-09T02:38:09Z</dcterms:created>
  <dcterms:modified xsi:type="dcterms:W3CDTF">2025-10-16T20:18:13Z</dcterms:modified>
</cp:coreProperties>
</file>